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6"/>
    <p:restoredTop sz="94658"/>
  </p:normalViewPr>
  <p:slideViewPr>
    <p:cSldViewPr snapToGrid="0" snapToObjects="1">
      <p:cViewPr varScale="1">
        <p:scale>
          <a:sx n="202" d="100"/>
          <a:sy n="202" d="100"/>
        </p:scale>
        <p:origin x="16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19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029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32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375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80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193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508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958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81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1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C188A-B100-A44A-AC37-33F639F287AE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3491B-2C19-D64E-9D4D-A1F992D19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253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236183"/>
              </p:ext>
            </p:extLst>
          </p:nvPr>
        </p:nvGraphicFramePr>
        <p:xfrm>
          <a:off x="827980" y="2045202"/>
          <a:ext cx="7184171" cy="3337561"/>
        </p:xfrm>
        <a:graphic>
          <a:graphicData uri="http://schemas.openxmlformats.org/drawingml/2006/table">
            <a:tbl>
              <a:tblPr firstRow="1" firstCol="1">
                <a:tableStyleId>{616DA210-FB5B-4158-B5E0-FEB733F419BA}</a:tableStyleId>
              </a:tblPr>
              <a:tblGrid>
                <a:gridCol w="142177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823199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62198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ron concentration (µM)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0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1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2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3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4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5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y-6</a:t>
                      </a:r>
                      <a:endParaRPr lang="mr-I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45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,c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71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29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30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18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,b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50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58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,b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00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05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36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18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,b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00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69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54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12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56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39</a:t>
                      </a:r>
                      <a:r>
                        <a:rPr lang="en-US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uk-UA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22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1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53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08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95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87</a:t>
                      </a:r>
                      <a:r>
                        <a:rPr lang="fi-FI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,c</a:t>
                      </a:r>
                      <a:endParaRPr lang="fi-FI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84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38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61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42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,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82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69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56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45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,c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63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41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,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77</a:t>
                      </a:r>
                      <a:r>
                        <a:rPr lang="en-US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uk-UA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68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60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84674"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0</a:t>
                      </a:r>
                      <a:endParaRPr lang="nb-NO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69</a:t>
                      </a:r>
                      <a:r>
                        <a:rPr lang="nb-NO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nb-NO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77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21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79</a:t>
                      </a:r>
                      <a:r>
                        <a:rPr lang="fi-FI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  <a:endParaRPr lang="fi-FI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64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4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53</a:t>
                      </a:r>
                      <a:r>
                        <a:rPr lang="hr-HR" sz="1400" u="none" strike="noStrike" baseline="300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</a:t>
                      </a:r>
                      <a:endParaRPr lang="hr-HR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27980" y="1269070"/>
            <a:ext cx="7184168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Table</a:t>
            </a:r>
            <a:r>
              <a:rPr lang="ja-JP" altLang="en-US" sz="1350" b="1" dirty="0">
                <a:latin typeface="Times New Roman" charset="0"/>
                <a:ea typeface="Times New Roman" charset="0"/>
                <a:cs typeface="Times New Roman" charset="0"/>
              </a:rPr>
              <a:t>　</a:t>
            </a:r>
            <a:r>
              <a:rPr lang="en-US" altLang="ja-JP" sz="1350" b="1" dirty="0">
                <a:latin typeface="Times New Roman" charset="0"/>
                <a:ea typeface="Times New Roman" charset="0"/>
                <a:cs typeface="Times New Roman" charset="0"/>
              </a:rPr>
              <a:t>S1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: OD</a:t>
            </a:r>
            <a:r>
              <a:rPr lang="en-US" sz="1350" b="1" baseline="-25000" dirty="0">
                <a:latin typeface="Times New Roman" charset="0"/>
                <a:ea typeface="Times New Roman" charset="0"/>
                <a:cs typeface="Times New Roman" charset="0"/>
              </a:rPr>
              <a:t>660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 values or growth of </a:t>
            </a:r>
            <a:r>
              <a:rPr lang="en-US" sz="1350" b="1" i="1" dirty="0">
                <a:latin typeface="Times New Roman" charset="0"/>
                <a:ea typeface="Times New Roman" charset="0"/>
                <a:cs typeface="Times New Roman" charset="0"/>
              </a:rPr>
              <a:t>R. </a:t>
            </a:r>
            <a:r>
              <a:rPr lang="en-US" sz="1350" b="1" i="1" dirty="0" err="1">
                <a:latin typeface="Times New Roman" charset="0"/>
                <a:ea typeface="Times New Roman" charset="0"/>
                <a:cs typeface="Times New Roman" charset="0"/>
              </a:rPr>
              <a:t>sulfidophilum</a:t>
            </a:r>
            <a:r>
              <a:rPr lang="en-US" sz="1350" b="1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in different iron concentrations. </a:t>
            </a:r>
            <a:r>
              <a:rPr lang="en-US" sz="1350" dirty="0">
                <a:latin typeface="Times New Roman" charset="0"/>
                <a:ea typeface="Times New Roman" charset="0"/>
                <a:cs typeface="Times New Roman" charset="0"/>
              </a:rPr>
              <a:t>Mean data accompanied by different superscripted letters are significantly different on the same day (Tukey’s HSD, p &lt; 0.05).</a:t>
            </a:r>
            <a:r>
              <a:rPr lang="en-US" sz="1350" b="1" dirty="0">
                <a:latin typeface="Times New Roman" charset="0"/>
                <a:ea typeface="Times New Roman" charset="0"/>
                <a:cs typeface="Times New Roman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961110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71</Words>
  <Application>Microsoft Macintosh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游ゴシック</vt:lpstr>
      <vt:lpstr>游ゴシック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Numata Keiji</cp:lastModifiedBy>
  <cp:revision>9</cp:revision>
  <dcterms:created xsi:type="dcterms:W3CDTF">2019-04-09T11:27:44Z</dcterms:created>
  <dcterms:modified xsi:type="dcterms:W3CDTF">2019-04-12T14:25:47Z</dcterms:modified>
</cp:coreProperties>
</file>